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F0F9"/>
    <a:srgbClr val="CDE3A5"/>
    <a:srgbClr val="FFFFCC"/>
    <a:srgbClr val="F7E1F4"/>
    <a:srgbClr val="F1CBC7"/>
    <a:srgbClr val="66FF33"/>
    <a:srgbClr val="F2CFEE"/>
    <a:srgbClr val="FD87A9"/>
    <a:srgbClr val="F793A1"/>
    <a:srgbClr val="F3D0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0" autoAdjust="0"/>
    <p:restoredTop sz="94660"/>
  </p:normalViewPr>
  <p:slideViewPr>
    <p:cSldViewPr snapToGrid="0">
      <p:cViewPr varScale="1">
        <p:scale>
          <a:sx n="74" d="100"/>
          <a:sy n="74" d="100"/>
        </p:scale>
        <p:origin x="91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D3227F-B8E1-42A0-9A98-E0D397CD00CE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7D662A-3A36-44A4-96D6-D1F22AA34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4380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ADAD26-6B58-0C91-BF02-E9A21717B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26E5AAB-AC63-E919-24F7-F1EEA8FD36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2330637-6A48-08C4-7A11-1F7D9AC72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4C202B-4789-D2C5-7DBA-C1995E344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315E78-09C6-0D38-533A-AE23FBC2B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4369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92666-D9E1-2A60-F8B6-7A0BD1E9A7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8013C86-8DFD-FC70-1821-35FA04286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21C723-B1C8-18EF-02CB-D00E157D3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D21EBE-AD45-CBB3-FBFD-0E4FBC2C6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5D74D8-537F-5244-2D57-AEAFCF05B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14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2A58440-FF56-8D98-BDA0-40D6A599E2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126D6FA-6AFF-7471-B9F5-AD539ECFFF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30C7D9-B554-0A78-8F98-D1EDA9745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4EAB8F-9E98-2576-464D-849D21EA0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2AB71-267C-C31A-39E8-43DFD017B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380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5FCCA2-BA3A-FF7F-E4DE-7ED4A0BD0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A37E07-ABF1-334B-42B5-3F5A2A6F7F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EB6AFB-5841-4970-DFC9-E52979B8E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84BD6C-DD67-FE5F-71EE-E64876285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2159EA-92D9-4AFD-FD3C-123C33E7C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324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699366-687D-C001-E0B7-1E5D0A125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4EBFC1-8ECB-A4F6-243D-E2CB7416A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88AB90-6214-9B77-6963-E2A0033EF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0F6732-9B0F-BB33-6079-7CFDE1F0E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396CF7-C65D-EBD1-4738-75C2BEEBD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576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DC7AC1-791F-4148-7158-627E7B0559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317ACF-3D6F-F2DF-0508-0B340E74A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D0673EF-30E9-C3B1-DA30-27BB8AD16A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9CB926-64FA-0E43-3E38-F7392EA48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765B0F-FDD4-AF7F-C24C-684D317DE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143EEA-B584-CA3A-BF73-EB99ED29D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155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46B975-BCB5-412D-87ED-DFE36561F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A7ACAC-E2F3-4CE5-3813-AFE6D3EA23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A01605-EB64-1DDF-4FF1-8F93187BA6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03C67FB-3B53-6697-1C72-C90CF35BA9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9F10467-5D56-0472-3B8F-CAFAB2803C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9947C2C-E131-B1FF-6BF7-194B208D5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DAD53ED-920B-9270-34D6-48CDC93B9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8072815-0AF2-A6DF-7FC0-073E51B65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990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A9D1C8-898A-B25B-5D78-DC34B1ABE9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2E0BD8E-BF24-05E4-88B0-CB330AFFD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26EDA26-DD62-C319-366A-5EB313A2C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5371F08-F41F-78F1-81D6-42EDB04DB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776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87CC08E-5BE0-9C6D-4B66-F1DC5476FE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66ABFE6-2327-DBDB-281F-DE549FFF9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E4B73D2-DEC7-AFCA-865D-E9C23A0F7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66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E85582-829D-63C1-6D2E-2DFC3666A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4A613F-01DB-251B-3DC8-E7F03CACFD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337597E-D018-0CD6-92DB-4A4358EE2B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341902-AC32-BC7C-2EA9-1946BEE1F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C13E81-2D65-6A1B-419F-7F9E32011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1E26F97-A138-563A-A1A2-AA11AD2DD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969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7A171A-C1A7-DC6C-625C-4BF03635A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0F4A95B-88D3-C74B-7907-81616916C4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4896CE-158D-CFA5-E3F0-D0F14646A1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B8DBED-3DE4-7753-1CEE-43FEE3929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0E11CD-7730-3779-1BAD-A49BD4B06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3656C18-7064-D021-485F-FBE363B04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546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5321953-6930-6B46-7792-692D34A62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E34B6F-40F9-A191-7FDA-1BCF210E3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D397F4-61BE-8E70-78C2-C23BE5FE21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72CB66-47F9-4CE4-CD01-B3E2CD345B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2CA156-17BD-BBB0-BB6F-2B0502A191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0319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pubmed.ncbi.nlm.nih.gov/?term=%28dysgraphia%5BTitle%2FAbstract%5D+OR+agraphia%5BTitle%2FAbstract%5D+OR+handwriting%5BTitle%2FAbstract%5D+OR+writing%5BTitle%2FAbstract%5D+OR+aphasia%5BTitle%2FAbstract%5D+OR+language+disturbance%5BTitle%2FAbstract%5D+OR+language+disturbances%5BTitle%2FAbstract%5D+OR+cognitive+dysfunction%5BTitle%2FAbstract%5D+OR+cognitive+dysfunctions+%5BTitle%2FAbstract%5D%29+AND+%28CAR+T%5BTitle%2FAbstract%5D+OR+CAR-T%5BTitle%2FAbstract%5D+OR+chimeric+antigen+receptor%5BTitle%2FAbstract%5D+OR+immune+effector+cell%5BTitle%2FAbstract%5D+OR+blinatumomab%5BTitle%2FAbstract%5D+OR+T-cell+engager%5BTitle%2FAbstract%5D+OR+T-cell+redirecting+bispecific+antibody%5BTitle%2FAbstract%5D%29+AND+%28ICANS%5BTitle%2FAbstract%5D+OR+neurotoxicity%5BTitle%2FAbstract%5D+OR+neurologic+toxicity%5BTitle%2FAbstract%5D+OR+encephalopathy%5BTitle%2FAbstract%5D%29&amp;sort=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F9100F2A-1383-F2A6-4EA0-B3F948C12B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4694735"/>
              </p:ext>
            </p:extLst>
          </p:nvPr>
        </p:nvGraphicFramePr>
        <p:xfrm>
          <a:off x="887327" y="574964"/>
          <a:ext cx="10140253" cy="586867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3126633">
                  <a:extLst>
                    <a:ext uri="{9D8B030D-6E8A-4147-A177-3AD203B41FA5}">
                      <a16:colId xmlns:a16="http://schemas.microsoft.com/office/drawing/2014/main" val="1909918592"/>
                    </a:ext>
                  </a:extLst>
                </a:gridCol>
                <a:gridCol w="3067639">
                  <a:extLst>
                    <a:ext uri="{9D8B030D-6E8A-4147-A177-3AD203B41FA5}">
                      <a16:colId xmlns:a16="http://schemas.microsoft.com/office/drawing/2014/main" val="2102488080"/>
                    </a:ext>
                  </a:extLst>
                </a:gridCol>
                <a:gridCol w="1546930">
                  <a:extLst>
                    <a:ext uri="{9D8B030D-6E8A-4147-A177-3AD203B41FA5}">
                      <a16:colId xmlns:a16="http://schemas.microsoft.com/office/drawing/2014/main" val="2475132485"/>
                    </a:ext>
                  </a:extLst>
                </a:gridCol>
                <a:gridCol w="2399051">
                  <a:extLst>
                    <a:ext uri="{9D8B030D-6E8A-4147-A177-3AD203B41FA5}">
                      <a16:colId xmlns:a16="http://schemas.microsoft.com/office/drawing/2014/main" val="2322266673"/>
                    </a:ext>
                  </a:extLst>
                </a:gridCol>
              </a:tblGrid>
              <a:tr h="214637">
                <a:tc gridSpan="4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3200" u="none" strike="noStrike" dirty="0">
                          <a:effectLst/>
                          <a:latin typeface="Britannic Bold" panose="020B0903060703020204" pitchFamily="34" charset="0"/>
                        </a:rPr>
                        <a:t>Search Method and Results</a:t>
                      </a:r>
                      <a:endParaRPr lang="en-US" sz="3200" b="0" i="0" u="none" strike="noStrike" dirty="0">
                        <a:solidFill>
                          <a:srgbClr val="000000"/>
                        </a:solidFill>
                        <a:effectLst/>
                        <a:latin typeface="Britannic Bold" panose="020B0903060703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5678" marR="5678" marT="5678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0730902"/>
                  </a:ext>
                </a:extLst>
              </a:tr>
              <a:tr h="253123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y Word group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PubMed Query</a:t>
                      </a:r>
                      <a:endParaRPr lang="en-US" sz="20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2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sults</a:t>
                      </a:r>
                      <a:endParaRPr lang="en-US" sz="28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2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 Date </a:t>
                      </a:r>
                      <a:endParaRPr lang="en-US" sz="20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extLst>
                  <a:ext uri="{0D108BD9-81ED-4DB2-BD59-A6C34878D82A}">
                    <a16:rowId xmlns:a16="http://schemas.microsoft.com/office/drawing/2014/main" val="1968445455"/>
                  </a:ext>
                </a:extLst>
              </a:tr>
              <a:tr h="4942917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dysgraphia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agraphia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handwriting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writing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aphasia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language disturbance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language disturbances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ognitive dysfunction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AR T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AR-T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himeric antigen receptor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immune effector cell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blinatumomab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ICANS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neurotoxicity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neurologic toxicity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encephalopath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dysgraphia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agraphia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handwriting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writing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aphasia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language disturbance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language disturbances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cognitive dysfunction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CAR T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CAR-T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chimeric antigen receptor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immune effector cell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blinatumomab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T-cell engager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T-cell redirecting bispecific antibody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ICANS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neurotoxicity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neurologic toxicity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OR encephalopathy[Title/Abstract]</a:t>
                      </a:r>
                      <a:b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600" u="sng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hlinkClick r:id="rId2"/>
                        </a:rPr>
                        <a:t>54</a:t>
                      </a:r>
                      <a:endParaRPr lang="ja-JP" altLang="en-US" sz="1600" b="0" i="0" u="sng" strike="noStrike" dirty="0">
                        <a:solidFill>
                          <a:srgbClr val="467886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6/3/25</a:t>
                      </a:r>
                      <a:endParaRPr lang="en-US" altLang="ja-JP" sz="11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5678" marR="5678" marT="5678" marB="0" anchor="ctr"/>
                </a:tc>
                <a:extLst>
                  <a:ext uri="{0D108BD9-81ED-4DB2-BD59-A6C34878D82A}">
                    <a16:rowId xmlns:a16="http://schemas.microsoft.com/office/drawing/2014/main" val="38663940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5885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0</TotalTime>
  <Words>269</Words>
  <Application>Microsoft Office PowerPoint</Application>
  <PresentationFormat>ワイド画面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Britannic Bold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eo Shimasaki</dc:creator>
  <cp:lastModifiedBy>Takeo Shimasaki</cp:lastModifiedBy>
  <cp:revision>46</cp:revision>
  <dcterms:created xsi:type="dcterms:W3CDTF">2025-12-30T00:16:26Z</dcterms:created>
  <dcterms:modified xsi:type="dcterms:W3CDTF">2026-03-27T00:58:36Z</dcterms:modified>
</cp:coreProperties>
</file>